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6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162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5639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2480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9923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5727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743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0600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7521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202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966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0247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2087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73D456-9132-41D0-A57B-11D7298D8163}" type="datetimeFigureOut">
              <a:rPr lang="en-GB" smtClean="0"/>
              <a:t>07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E25A1-0223-4D0F-98A0-F58DE904D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7193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Manu\Desktop\LSM-BT\Z-stack\fdc2\fdc2.gif">
            <a:extLst>
              <a:ext uri="{FF2B5EF4-FFF2-40B4-BE49-F238E27FC236}">
                <a16:creationId xmlns:a16="http://schemas.microsoft.com/office/drawing/2014/main" id="{ACFB7122-BF1C-9561-CF80-C08B8F2F84FA}"/>
              </a:ext>
            </a:extLst>
          </p:cNvPr>
          <p:cNvPicPr>
            <a:picLocks noChangeAspect="1" noChangeArrowheads="1" noCrop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642" y="557546"/>
            <a:ext cx="5742906" cy="5742906"/>
          </a:xfrm>
          <a:prstGeom prst="rect">
            <a:avLst/>
          </a:prstGeom>
          <a:noFill/>
          <a:ln w="25400">
            <a:solidFill>
              <a:schemeClr val="accent1">
                <a:lumMod val="75000"/>
                <a:alpha val="50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787128-1582-E9FF-521B-8356C26AB2F3}"/>
              </a:ext>
            </a:extLst>
          </p:cNvPr>
          <p:cNvSpPr txBox="1"/>
          <p:nvPr/>
        </p:nvSpPr>
        <p:spPr>
          <a:xfrm>
            <a:off x="6372519" y="889843"/>
            <a:ext cx="239441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0" i="0" u="none" strike="noStrike" baseline="0" dirty="0">
                <a:latin typeface="ArialMT"/>
              </a:rPr>
              <a:t>Figure S4. Z-stack through a typical entire protoplast expressing FdC2-GFP tagged protein (see Fig. 8). Images were taken by laser scanning microscopy, 18 h after transformation of </a:t>
            </a:r>
            <a:r>
              <a:rPr lang="en-GB" sz="1200" b="0" i="0" u="none" strike="noStrike" baseline="0" dirty="0" err="1">
                <a:latin typeface="ArialMT"/>
              </a:rPr>
              <a:t>wt</a:t>
            </a:r>
            <a:r>
              <a:rPr lang="en-GB" sz="1200" b="0" i="0" u="none" strike="noStrike" baseline="0" dirty="0">
                <a:latin typeface="ArialMT"/>
              </a:rPr>
              <a:t> Arabidopsis protoplasts. Green shows FdC2-GFP, red shows chlorophyll autofluorescence. Images were recorded at 1.3 µm depth intervals through the protoplast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567242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7</TotalTime>
  <Words>5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MT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y Hanke</dc:creator>
  <cp:lastModifiedBy>Guy Hanke</cp:lastModifiedBy>
  <cp:revision>2</cp:revision>
  <dcterms:created xsi:type="dcterms:W3CDTF">2023-06-09T11:10:16Z</dcterms:created>
  <dcterms:modified xsi:type="dcterms:W3CDTF">2023-07-07T12:28:52Z</dcterms:modified>
</cp:coreProperties>
</file>